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61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BDAB19-D74A-41FB-769E-E27988CD2F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1D7EB0-9FFF-1E96-3450-8F1065212B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24AA84-52E6-166D-C272-A4DF93537D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FCEA6-4AFD-4B0C-A844-B4806419F3B1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DDF045-B129-FE23-EB11-3496FC7F46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8D441C-2A5D-D8CB-67EC-C4546350D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BF5CF-99AC-4F84-9256-9329C299E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089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8B6788-F9CE-6FE2-C092-32CFEF56D9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4FD03C-E9DF-F6FA-8AFF-D66A530B3F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A53106-6BA5-FCF3-C77F-09755A94A7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FCEA6-4AFD-4B0C-A844-B4806419F3B1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FA7E58-78F9-D9A8-ACC9-D36D5618AD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D845DA-A009-F030-9CD6-36D201791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BF5CF-99AC-4F84-9256-9329C299E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722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532BB8-5C37-85DD-99C3-C031D944DB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67BAE7-65B2-1B2B-6652-9E55B364C4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31FDD4-201C-66FD-BC52-598325568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FCEA6-4AFD-4B0C-A844-B4806419F3B1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C68421-9FE0-4060-DDF0-C09328078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697955-9A10-DF03-19F1-27669F05C3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BF5CF-99AC-4F84-9256-9329C299E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7826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8E67E4-36A8-8689-F58D-DA095A4AFF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E56AEF-E223-AAD3-A4E8-8A04C123BB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AB5FEA-3FAC-147F-34C3-87D836F995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FCEA6-4AFD-4B0C-A844-B4806419F3B1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A90E19-66FF-1863-899C-B5FA257D5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BD4C73-BC22-0D20-010C-45E393CDA6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BF5CF-99AC-4F84-9256-9329C299E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661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540CD0-55C3-BA8D-52DD-63CE6ECB4D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2A75E3-EAB7-817B-CD08-400BD8D278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2FC02C-CD57-CED6-07EF-8CF80ADEA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FCEA6-4AFD-4B0C-A844-B4806419F3B1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23BD46-2246-FA8C-728A-9E1472158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EBEB1-EB2A-E426-F3E7-352169D3BE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BF5CF-99AC-4F84-9256-9329C299E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554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737630-B93B-0A7C-E5A9-A469CC98E8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F8AD01-2667-4F71-D7C9-E402FBE546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B63EFE-C434-11FF-7051-7196FB5043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3D3BB6-AD6E-D3A8-4981-04E451C1DF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FCEA6-4AFD-4B0C-A844-B4806419F3B1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51425F-1E3C-6A61-3B30-A18FAD27EB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F16CB2-B191-99BD-48C9-87B8D5976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BF5CF-99AC-4F84-9256-9329C299E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082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C9B18-4535-8F5B-35D8-9DBD5A187C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DF87A2-BC29-9A19-0D54-47CFD19E2A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46371B-2802-9B03-0520-0127719D3B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4E1C32-60CA-56B8-0B14-4EE709B146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B1E6371-0620-E75A-1DD6-039B2FBFD6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7C15F37-2DE5-E216-9C5E-14A3E3C3A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FCEA6-4AFD-4B0C-A844-B4806419F3B1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12601E-489C-A4B5-1CC3-9FF04284BF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F1F266-E803-DD57-446F-1078953B7F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BF5CF-99AC-4F84-9256-9329C299E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735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96C52C-1EFA-2EA1-FD4D-A58F4206F5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731F19-FF6B-2DAA-72BC-75BDD32FB6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FCEA6-4AFD-4B0C-A844-B4806419F3B1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5154D23-3C90-20AA-9971-7C1BD03B5D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EC57A92-75BF-C1D2-1081-3E92410A48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BF5CF-99AC-4F84-9256-9329C299E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335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FB1B0B7-AC5D-260E-72DB-55F4265F9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FCEA6-4AFD-4B0C-A844-B4806419F3B1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907D6B-A708-22E7-ADBB-A334C8D08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B8751A-CEDC-A102-B4F8-8AC3E22499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BF5CF-99AC-4F84-9256-9329C299E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556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E0751E-A876-BBCC-B85A-731F6C017F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7003CA-D632-E309-EF50-8A0BBC43B3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5DDD60-2372-3718-66DA-72BA7B9414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826FD3-E9F4-999F-BA32-2F3D15101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FCEA6-4AFD-4B0C-A844-B4806419F3B1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C26DD9-DACF-3A3B-18C2-96C1DF5D9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973968-C4DD-1644-8316-154DE2A0A3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BF5CF-99AC-4F84-9256-9329C299E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9374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A2C3EF-2E6F-757D-7109-47E23B7034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BA80AC7-2139-15E1-61F1-D5B14A4E4C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BAE274-6364-76FF-62CE-D8E68BDB55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C80CEC-6891-5868-1E4C-6FB0D51B7E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FCEA6-4AFD-4B0C-A844-B4806419F3B1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2F9013-64A1-C79A-844A-54933E6AE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B6D6D2-57D1-6264-B7F4-29BD2F7931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BF5CF-99AC-4F84-9256-9329C299E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78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8649012-D359-58D0-8910-6F5194083B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6A3E29-27F3-20AD-2A09-3769F592C5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95FB38-71DB-1AE9-FB46-CAF770B7EB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F8FCEA6-4AFD-4B0C-A844-B4806419F3B1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C69CA0-1B4A-8451-D441-351DD5152A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EB7730-D2B6-9787-89E6-E5A7FD849CE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2CBF5CF-99AC-4F84-9256-9329C299E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5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45086" y="599815"/>
            <a:ext cx="51512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4 Table . Characteristics of 2 PWH on ART for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cRNA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seq analysis.</a:t>
            </a:r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1482811" y="1248508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Rectangle 7"/>
          <p:cNvSpPr>
            <a:spLocks noChangeArrowheads="1"/>
          </p:cNvSpPr>
          <p:nvPr/>
        </p:nvSpPr>
        <p:spPr bwMode="auto">
          <a:xfrm>
            <a:off x="1482811" y="1705708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8" name="Table 7"/>
          <p:cNvGraphicFramePr>
            <a:graphicFrameLocks noGrp="1"/>
          </p:cNvGraphicFramePr>
          <p:nvPr/>
        </p:nvGraphicFramePr>
        <p:xfrm>
          <a:off x="412038" y="876207"/>
          <a:ext cx="10459453" cy="1248790"/>
        </p:xfrm>
        <a:graphic>
          <a:graphicData uri="http://schemas.openxmlformats.org/drawingml/2006/table">
            <a:tbl>
              <a:tblPr firstRow="1" firstCol="1" bandRow="1">
                <a:tableStyleId>{7E9639D4-E3E2-4D34-9284-5A2195B3D0D7}</a:tableStyleId>
              </a:tblPr>
              <a:tblGrid>
                <a:gridCol w="440575">
                  <a:extLst>
                    <a:ext uri="{9D8B030D-6E8A-4147-A177-3AD203B41FA5}">
                      <a16:colId xmlns:a16="http://schemas.microsoft.com/office/drawing/2014/main" val="928472017"/>
                    </a:ext>
                  </a:extLst>
                </a:gridCol>
                <a:gridCol w="573326">
                  <a:extLst>
                    <a:ext uri="{9D8B030D-6E8A-4147-A177-3AD203B41FA5}">
                      <a16:colId xmlns:a16="http://schemas.microsoft.com/office/drawing/2014/main" val="2770612201"/>
                    </a:ext>
                  </a:extLst>
                </a:gridCol>
                <a:gridCol w="539646">
                  <a:extLst>
                    <a:ext uri="{9D8B030D-6E8A-4147-A177-3AD203B41FA5}">
                      <a16:colId xmlns:a16="http://schemas.microsoft.com/office/drawing/2014/main" val="3119824515"/>
                    </a:ext>
                  </a:extLst>
                </a:gridCol>
                <a:gridCol w="1411679">
                  <a:extLst>
                    <a:ext uri="{9D8B030D-6E8A-4147-A177-3AD203B41FA5}">
                      <a16:colId xmlns:a16="http://schemas.microsoft.com/office/drawing/2014/main" val="2805622023"/>
                    </a:ext>
                  </a:extLst>
                </a:gridCol>
                <a:gridCol w="902084">
                  <a:extLst>
                    <a:ext uri="{9D8B030D-6E8A-4147-A177-3AD203B41FA5}">
                      <a16:colId xmlns:a16="http://schemas.microsoft.com/office/drawing/2014/main" val="1778168068"/>
                    </a:ext>
                  </a:extLst>
                </a:gridCol>
                <a:gridCol w="945452">
                  <a:extLst>
                    <a:ext uri="{9D8B030D-6E8A-4147-A177-3AD203B41FA5}">
                      <a16:colId xmlns:a16="http://schemas.microsoft.com/office/drawing/2014/main" val="3374709181"/>
                    </a:ext>
                  </a:extLst>
                </a:gridCol>
                <a:gridCol w="902083">
                  <a:extLst>
                    <a:ext uri="{9D8B030D-6E8A-4147-A177-3AD203B41FA5}">
                      <a16:colId xmlns:a16="http://schemas.microsoft.com/office/drawing/2014/main" val="4170582525"/>
                    </a:ext>
                  </a:extLst>
                </a:gridCol>
                <a:gridCol w="919431">
                  <a:extLst>
                    <a:ext uri="{9D8B030D-6E8A-4147-A177-3AD203B41FA5}">
                      <a16:colId xmlns:a16="http://schemas.microsoft.com/office/drawing/2014/main" val="3758409935"/>
                    </a:ext>
                  </a:extLst>
                </a:gridCol>
                <a:gridCol w="841365">
                  <a:extLst>
                    <a:ext uri="{9D8B030D-6E8A-4147-A177-3AD203B41FA5}">
                      <a16:colId xmlns:a16="http://schemas.microsoft.com/office/drawing/2014/main" val="1642022905"/>
                    </a:ext>
                  </a:extLst>
                </a:gridCol>
                <a:gridCol w="719931">
                  <a:extLst>
                    <a:ext uri="{9D8B030D-6E8A-4147-A177-3AD203B41FA5}">
                      <a16:colId xmlns:a16="http://schemas.microsoft.com/office/drawing/2014/main" val="2971482137"/>
                    </a:ext>
                  </a:extLst>
                </a:gridCol>
                <a:gridCol w="1101582">
                  <a:extLst>
                    <a:ext uri="{9D8B030D-6E8A-4147-A177-3AD203B41FA5}">
                      <a16:colId xmlns:a16="http://schemas.microsoft.com/office/drawing/2014/main" val="2084825245"/>
                    </a:ext>
                  </a:extLst>
                </a:gridCol>
                <a:gridCol w="1162299">
                  <a:extLst>
                    <a:ext uri="{9D8B030D-6E8A-4147-A177-3AD203B41FA5}">
                      <a16:colId xmlns:a16="http://schemas.microsoft.com/office/drawing/2014/main" val="1270996390"/>
                    </a:ext>
                  </a:extLst>
                </a:gridCol>
              </a:tblGrid>
              <a:tr h="38137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onor</a:t>
                      </a:r>
                    </a:p>
                  </a:txBody>
                  <a:tcPr marL="7303" marR="7303" marT="7303" marB="730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WH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D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der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rminal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eas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ce/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thnicity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RT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uration</a:t>
                      </a:r>
                    </a:p>
                  </a:txBody>
                  <a:tcPr marL="7303" marR="7303" marT="7303" marB="730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opped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T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t ART Regimen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t Viral Load value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t CD4 count 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t CD4 (days before death)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t VL days before death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1272907"/>
                  </a:ext>
                </a:extLst>
              </a:tr>
              <a:tr h="25055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cs typeface="Arial"/>
                        </a:rPr>
                        <a:t>LG29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 Cancer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ucasian/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Hispanic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aseline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5 years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TC/TAF/</a:t>
                      </a: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TG</a:t>
                      </a:r>
                      <a:endParaRPr lang="en-US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30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7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6886897"/>
                  </a:ext>
                </a:extLst>
              </a:tr>
              <a:tr h="25055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7</a:t>
                      </a: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espiratory Arrest/Pulmonary Edema</a:t>
                      </a: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aucasian</a:t>
                      </a: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100" baseline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aseline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ars</a:t>
                      </a:r>
                      <a:r>
                        <a:rPr lang="en-US" sz="1100" baseline="3000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100" baseline="30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 (7</a:t>
                      </a:r>
                      <a:r>
                        <a:rPr lang="en-US" sz="1100" baseline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days before death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iktarvy</a:t>
                      </a:r>
                      <a:endParaRPr lang="en-US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Arial"/>
                        </a:rPr>
                        <a:t>n.a.</a:t>
                      </a: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Arial"/>
                        </a:rPr>
                        <a:t>n.a.</a:t>
                      </a: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Arial"/>
                          <a:ea typeface="Calibri"/>
                          <a:cs typeface="Arial"/>
                        </a:rPr>
                        <a:t>n.a.</a:t>
                      </a: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  <a:latin typeface="Arial"/>
                          <a:ea typeface="Calibri"/>
                          <a:cs typeface="Arial"/>
                        </a:rPr>
                        <a:t>n.a</a:t>
                      </a:r>
                      <a:r>
                        <a:rPr lang="en-US" sz="1100" dirty="0">
                          <a:effectLst/>
                          <a:latin typeface="Arial"/>
                          <a:ea typeface="Calibri"/>
                          <a:cs typeface="Arial"/>
                        </a:rPr>
                        <a:t>.</a:t>
                      </a:r>
                    </a:p>
                  </a:txBody>
                  <a:tcPr marL="7303" marR="7303" marT="7303" marB="73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786217"/>
                  </a:ext>
                </a:extLst>
              </a:tr>
            </a:tbl>
          </a:graphicData>
        </a:graphic>
      </p:graphicFrame>
      <p:sp>
        <p:nvSpPr>
          <p:cNvPr id="9" name="Rectangle 8"/>
          <p:cNvSpPr/>
          <p:nvPr/>
        </p:nvSpPr>
        <p:spPr>
          <a:xfrm>
            <a:off x="324115" y="2124997"/>
            <a:ext cx="1054737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hort abbreviations: LG: The “Last Gift” cohort; N: NDRI cohort. Drug abbreviations: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TC, Emtricitabine;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AF,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enofovir Alafenamide;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TG, Dolutegravir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.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, data not available. Gender abbreviations: TF, transgender; F, female; 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his NDRI donor has been on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iktarvy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or at least 2 years bu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topped ART 7 days before death.</a:t>
            </a:r>
          </a:p>
        </p:txBody>
      </p:sp>
    </p:spTree>
    <p:extLst>
      <p:ext uri="{BB962C8B-B14F-4D97-AF65-F5344CB8AC3E}">
        <p14:creationId xmlns:p14="http://schemas.microsoft.com/office/powerpoint/2010/main" val="3954578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6</Words>
  <Application>Microsoft Office PowerPoint</Application>
  <PresentationFormat>Widescreen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19:59:24Z</dcterms:created>
  <dcterms:modified xsi:type="dcterms:W3CDTF">2025-07-28T20:00:10Z</dcterms:modified>
</cp:coreProperties>
</file>